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96" r:id="rId1"/>
  </p:sldMasterIdLst>
  <p:sldIdLst>
    <p:sldId id="260" r:id="rId2"/>
  </p:sldIdLst>
  <p:sldSz cx="6858000" cy="9144000" type="screen4x3"/>
  <p:notesSz cx="6858000" cy="9144000"/>
  <p:custDataLst>
    <p:tags r:id="rId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503" userDrawn="1">
          <p15:clr>
            <a:srgbClr val="A4A3A4"/>
          </p15:clr>
        </p15:guide>
        <p15:guide id="3" orient="horz" pos="4578" userDrawn="1">
          <p15:clr>
            <a:srgbClr val="A4A3A4"/>
          </p15:clr>
        </p15:guide>
        <p15:guide id="4" orient="horz" pos="1728" userDrawn="1">
          <p15:clr>
            <a:srgbClr val="A4A3A4"/>
          </p15:clr>
        </p15:guide>
        <p15:guide id="5" pos="979" userDrawn="1">
          <p15:clr>
            <a:srgbClr val="A4A3A4"/>
          </p15:clr>
        </p15:guide>
        <p15:guide id="6" orient="horz" pos="612" userDrawn="1">
          <p15:clr>
            <a:srgbClr val="A4A3A4"/>
          </p15:clr>
        </p15:guide>
        <p15:guide id="7" orient="horz" pos="2903" userDrawn="1">
          <p15:clr>
            <a:srgbClr val="A4A3A4"/>
          </p15:clr>
        </p15:guide>
        <p15:guide id="8" orient="horz" pos="476" userDrawn="1">
          <p15:clr>
            <a:srgbClr val="A4A3A4"/>
          </p15:clr>
        </p15:guide>
        <p15:guide id="9" orient="horz" pos="269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2458" y="62"/>
      </p:cViewPr>
      <p:guideLst>
        <p:guide pos="503"/>
        <p:guide orient="horz" pos="4578"/>
        <p:guide orient="horz" pos="1728"/>
        <p:guide pos="979"/>
        <p:guide orient="horz" pos="612"/>
        <p:guide orient="horz" pos="2903"/>
        <p:guide orient="horz" pos="476"/>
        <p:guide orient="horz" pos="269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736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759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2333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7029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6352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510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2585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7295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9037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9905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2383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705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图片 33">
            <a:extLst>
              <a:ext uri="{FF2B5EF4-FFF2-40B4-BE49-F238E27FC236}">
                <a16:creationId xmlns:a16="http://schemas.microsoft.com/office/drawing/2014/main" id="{68F660CC-2354-DC8C-36FF-52F58A92C9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7324" y="3994331"/>
            <a:ext cx="4036807" cy="3198615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CAB9FBAB-CBF7-8D5D-C80F-4DBAF4D7A4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5744" y="780001"/>
            <a:ext cx="4668019" cy="3081143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1949115" y="2051904"/>
            <a:ext cx="121518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862561" y="471424"/>
            <a:ext cx="372218" cy="4050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203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3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952099" y="147082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###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B822A57-58D9-9271-D2F9-54EEA3831626}"/>
              </a:ext>
            </a:extLst>
          </p:cNvPr>
          <p:cNvSpPr txBox="1"/>
          <p:nvPr/>
        </p:nvSpPr>
        <p:spPr>
          <a:xfrm>
            <a:off x="3653100" y="1764133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8CD3F9E-D51F-2DD5-9C1F-31C3753BC835}"/>
              </a:ext>
            </a:extLst>
          </p:cNvPr>
          <p:cNvSpPr txBox="1"/>
          <p:nvPr/>
        </p:nvSpPr>
        <p:spPr>
          <a:xfrm>
            <a:off x="4212678" y="195750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E8251CD-ADF4-4CDC-6195-B472AFD97875}"/>
              </a:ext>
            </a:extLst>
          </p:cNvPr>
          <p:cNvSpPr txBox="1"/>
          <p:nvPr/>
        </p:nvSpPr>
        <p:spPr>
          <a:xfrm>
            <a:off x="4854131" y="1855748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862561" y="3986100"/>
            <a:ext cx="372218" cy="4050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203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3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DC071F2-BBA7-992B-928A-92F8F2223C4A}"/>
              </a:ext>
            </a:extLst>
          </p:cNvPr>
          <p:cNvSpPr txBox="1"/>
          <p:nvPr/>
        </p:nvSpPr>
        <p:spPr>
          <a:xfrm>
            <a:off x="30480" y="7326133"/>
            <a:ext cx="68275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: (A,B) The anti-PD action of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ryptochlorogenic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cid was assessed by analyzing PD-like behavior. ***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&lt;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0.001 vs.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tl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#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5 , 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##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1, 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###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&lt; 0.001 vs. </a:t>
            </a:r>
            <a:r>
              <a:rPr lang="en-US" sz="1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PTP</a:t>
            </a:r>
            <a:r>
              <a:rPr lang="en-US">
                <a:effectLst/>
              </a:rPr>
              <a:t> </a:t>
            </a:r>
            <a:r>
              <a:rPr lang="en-US" sz="1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WQ5NTBmMzU3ZDg5ZjdmNDA3NGI3NDExMTRkMjI2YmQ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8</TotalTime>
  <Words>56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MDPI</cp:lastModifiedBy>
  <cp:revision>111</cp:revision>
  <dcterms:created xsi:type="dcterms:W3CDTF">2023-11-07T05:59:00Z</dcterms:created>
  <dcterms:modified xsi:type="dcterms:W3CDTF">2025-03-17T05:50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CFDA21B966449CC87956D38D1BC4692_12</vt:lpwstr>
  </property>
  <property fmtid="{D5CDD505-2E9C-101B-9397-08002B2CF9AE}" pid="3" name="KSOProductBuildVer">
    <vt:lpwstr>2052-12.1.0.16417</vt:lpwstr>
  </property>
</Properties>
</file>